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3600450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1" userDrawn="1">
          <p15:clr>
            <a:srgbClr val="A4A3A4"/>
          </p15:clr>
        </p15:guide>
        <p15:guide id="2" pos="113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ikorski, Franziska" initials="SF" lastIdx="0" clrIdx="0">
    <p:extLst>
      <p:ext uri="{19B8F6BF-5375-455C-9EA6-DF929625EA0E}">
        <p15:presenceInfo xmlns:p15="http://schemas.microsoft.com/office/powerpoint/2012/main" userId="S-1-5-21-1415759971-1158191895-317929798-6027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67171"/>
    <a:srgbClr val="020044"/>
    <a:srgbClr val="EEFBFA"/>
    <a:srgbClr val="52358E"/>
    <a:srgbClr val="D67A94"/>
    <a:srgbClr val="4BC4B1"/>
    <a:srgbClr val="46C1AD"/>
    <a:srgbClr val="51C6B2"/>
    <a:srgbClr val="E8F9F7"/>
    <a:srgbClr val="E9FA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24" autoAdjust="0"/>
    <p:restoredTop sz="94660"/>
  </p:normalViewPr>
  <p:slideViewPr>
    <p:cSldViewPr snapToGrid="0">
      <p:cViewPr varScale="1">
        <p:scale>
          <a:sx n="87" d="100"/>
          <a:sy n="87" d="100"/>
        </p:scale>
        <p:origin x="1728" y="84"/>
      </p:cViewPr>
      <p:guideLst>
        <p:guide orient="horz" pos="131"/>
        <p:guide pos="11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0034" y="883861"/>
            <a:ext cx="3060383" cy="1880235"/>
          </a:xfrm>
        </p:spPr>
        <p:txBody>
          <a:bodyPr anchor="b"/>
          <a:lstStyle>
            <a:lvl1pPr algn="ctr">
              <a:defRPr sz="2363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0056" y="2836605"/>
            <a:ext cx="2700338" cy="1303913"/>
          </a:xfrm>
        </p:spPr>
        <p:txBody>
          <a:bodyPr/>
          <a:lstStyle>
            <a:lvl1pPr marL="0" indent="0" algn="ctr">
              <a:buNone/>
              <a:defRPr sz="945"/>
            </a:lvl1pPr>
            <a:lvl2pPr marL="180045" indent="0" algn="ctr">
              <a:buNone/>
              <a:defRPr sz="788"/>
            </a:lvl2pPr>
            <a:lvl3pPr marL="360091" indent="0" algn="ctr">
              <a:buNone/>
              <a:defRPr sz="709"/>
            </a:lvl3pPr>
            <a:lvl4pPr marL="540136" indent="0" algn="ctr">
              <a:buNone/>
              <a:defRPr sz="630"/>
            </a:lvl4pPr>
            <a:lvl5pPr marL="720181" indent="0" algn="ctr">
              <a:buNone/>
              <a:defRPr sz="630"/>
            </a:lvl5pPr>
            <a:lvl6pPr marL="900227" indent="0" algn="ctr">
              <a:buNone/>
              <a:defRPr sz="630"/>
            </a:lvl6pPr>
            <a:lvl7pPr marL="1080272" indent="0" algn="ctr">
              <a:buNone/>
              <a:defRPr sz="630"/>
            </a:lvl7pPr>
            <a:lvl8pPr marL="1260318" indent="0" algn="ctr">
              <a:buNone/>
              <a:defRPr sz="630"/>
            </a:lvl8pPr>
            <a:lvl9pPr marL="1440363" indent="0" algn="ctr">
              <a:buNone/>
              <a:defRPr sz="63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0778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8467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6572" y="287536"/>
            <a:ext cx="776347" cy="4576822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531" y="287536"/>
            <a:ext cx="2284035" cy="4576822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7782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4619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656" y="1346420"/>
            <a:ext cx="3105388" cy="2246530"/>
          </a:xfrm>
        </p:spPr>
        <p:txBody>
          <a:bodyPr anchor="b"/>
          <a:lstStyle>
            <a:lvl1pPr>
              <a:defRPr sz="2363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656" y="3614203"/>
            <a:ext cx="3105388" cy="1181397"/>
          </a:xfrm>
        </p:spPr>
        <p:txBody>
          <a:bodyPr/>
          <a:lstStyle>
            <a:lvl1pPr marL="0" indent="0">
              <a:buNone/>
              <a:defRPr sz="945">
                <a:solidFill>
                  <a:schemeClr val="tx1"/>
                </a:solidFill>
              </a:defRPr>
            </a:lvl1pPr>
            <a:lvl2pPr marL="180045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2pPr>
            <a:lvl3pPr marL="360091" indent="0">
              <a:buNone/>
              <a:defRPr sz="709">
                <a:solidFill>
                  <a:schemeClr val="tx1">
                    <a:tint val="75000"/>
                  </a:schemeClr>
                </a:solidFill>
              </a:defRPr>
            </a:lvl3pPr>
            <a:lvl4pPr marL="540136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4pPr>
            <a:lvl5pPr marL="720181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5pPr>
            <a:lvl6pPr marL="900227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6pPr>
            <a:lvl7pPr marL="1080272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7pPr>
            <a:lvl8pPr marL="1260318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8pPr>
            <a:lvl9pPr marL="1440363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6581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531" y="1437680"/>
            <a:ext cx="1530191" cy="34266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2728" y="1437680"/>
            <a:ext cx="1530191" cy="34266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388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8000" y="287537"/>
            <a:ext cx="3105388" cy="1043881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8000" y="1323916"/>
            <a:ext cx="1523159" cy="648831"/>
          </a:xfrm>
        </p:spPr>
        <p:txBody>
          <a:bodyPr anchor="b"/>
          <a:lstStyle>
            <a:lvl1pPr marL="0" indent="0">
              <a:buNone/>
              <a:defRPr sz="945" b="1"/>
            </a:lvl1pPr>
            <a:lvl2pPr marL="180045" indent="0">
              <a:buNone/>
              <a:defRPr sz="788" b="1"/>
            </a:lvl2pPr>
            <a:lvl3pPr marL="360091" indent="0">
              <a:buNone/>
              <a:defRPr sz="709" b="1"/>
            </a:lvl3pPr>
            <a:lvl4pPr marL="540136" indent="0">
              <a:buNone/>
              <a:defRPr sz="630" b="1"/>
            </a:lvl4pPr>
            <a:lvl5pPr marL="720181" indent="0">
              <a:buNone/>
              <a:defRPr sz="630" b="1"/>
            </a:lvl5pPr>
            <a:lvl6pPr marL="900227" indent="0">
              <a:buNone/>
              <a:defRPr sz="630" b="1"/>
            </a:lvl6pPr>
            <a:lvl7pPr marL="1080272" indent="0">
              <a:buNone/>
              <a:defRPr sz="630" b="1"/>
            </a:lvl7pPr>
            <a:lvl8pPr marL="1260318" indent="0">
              <a:buNone/>
              <a:defRPr sz="630" b="1"/>
            </a:lvl8pPr>
            <a:lvl9pPr marL="1440363" indent="0">
              <a:buNone/>
              <a:defRPr sz="63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8000" y="1972747"/>
            <a:ext cx="1523159" cy="290161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2728" y="1323916"/>
            <a:ext cx="1530660" cy="648831"/>
          </a:xfrm>
        </p:spPr>
        <p:txBody>
          <a:bodyPr anchor="b"/>
          <a:lstStyle>
            <a:lvl1pPr marL="0" indent="0">
              <a:buNone/>
              <a:defRPr sz="945" b="1"/>
            </a:lvl1pPr>
            <a:lvl2pPr marL="180045" indent="0">
              <a:buNone/>
              <a:defRPr sz="788" b="1"/>
            </a:lvl2pPr>
            <a:lvl3pPr marL="360091" indent="0">
              <a:buNone/>
              <a:defRPr sz="709" b="1"/>
            </a:lvl3pPr>
            <a:lvl4pPr marL="540136" indent="0">
              <a:buNone/>
              <a:defRPr sz="630" b="1"/>
            </a:lvl4pPr>
            <a:lvl5pPr marL="720181" indent="0">
              <a:buNone/>
              <a:defRPr sz="630" b="1"/>
            </a:lvl5pPr>
            <a:lvl6pPr marL="900227" indent="0">
              <a:buNone/>
              <a:defRPr sz="630" b="1"/>
            </a:lvl6pPr>
            <a:lvl7pPr marL="1080272" indent="0">
              <a:buNone/>
              <a:defRPr sz="630" b="1"/>
            </a:lvl7pPr>
            <a:lvl8pPr marL="1260318" indent="0">
              <a:buNone/>
              <a:defRPr sz="630" b="1"/>
            </a:lvl8pPr>
            <a:lvl9pPr marL="1440363" indent="0">
              <a:buNone/>
              <a:defRPr sz="63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2728" y="1972747"/>
            <a:ext cx="1530660" cy="290161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2852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729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0274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8000" y="360045"/>
            <a:ext cx="1161239" cy="1260158"/>
          </a:xfrm>
        </p:spPr>
        <p:txBody>
          <a:bodyPr anchor="b"/>
          <a:lstStyle>
            <a:lvl1pPr>
              <a:defRPr sz="126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0660" y="777598"/>
            <a:ext cx="1822728" cy="3837980"/>
          </a:xfrm>
        </p:spPr>
        <p:txBody>
          <a:bodyPr/>
          <a:lstStyle>
            <a:lvl1pPr>
              <a:defRPr sz="1260"/>
            </a:lvl1pPr>
            <a:lvl2pPr>
              <a:defRPr sz="1103"/>
            </a:lvl2pPr>
            <a:lvl3pPr>
              <a:defRPr sz="945"/>
            </a:lvl3pPr>
            <a:lvl4pPr>
              <a:defRPr sz="788"/>
            </a:lvl4pPr>
            <a:lvl5pPr>
              <a:defRPr sz="788"/>
            </a:lvl5pPr>
            <a:lvl6pPr>
              <a:defRPr sz="788"/>
            </a:lvl6pPr>
            <a:lvl7pPr>
              <a:defRPr sz="788"/>
            </a:lvl7pPr>
            <a:lvl8pPr>
              <a:defRPr sz="788"/>
            </a:lvl8pPr>
            <a:lvl9pPr>
              <a:defRPr sz="788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8000" y="1620202"/>
            <a:ext cx="1161239" cy="3001626"/>
          </a:xfrm>
        </p:spPr>
        <p:txBody>
          <a:bodyPr/>
          <a:lstStyle>
            <a:lvl1pPr marL="0" indent="0">
              <a:buNone/>
              <a:defRPr sz="630"/>
            </a:lvl1pPr>
            <a:lvl2pPr marL="180045" indent="0">
              <a:buNone/>
              <a:defRPr sz="551"/>
            </a:lvl2pPr>
            <a:lvl3pPr marL="360091" indent="0">
              <a:buNone/>
              <a:defRPr sz="473"/>
            </a:lvl3pPr>
            <a:lvl4pPr marL="540136" indent="0">
              <a:buNone/>
              <a:defRPr sz="394"/>
            </a:lvl4pPr>
            <a:lvl5pPr marL="720181" indent="0">
              <a:buNone/>
              <a:defRPr sz="394"/>
            </a:lvl5pPr>
            <a:lvl6pPr marL="900227" indent="0">
              <a:buNone/>
              <a:defRPr sz="394"/>
            </a:lvl6pPr>
            <a:lvl7pPr marL="1080272" indent="0">
              <a:buNone/>
              <a:defRPr sz="394"/>
            </a:lvl7pPr>
            <a:lvl8pPr marL="1260318" indent="0">
              <a:buNone/>
              <a:defRPr sz="394"/>
            </a:lvl8pPr>
            <a:lvl9pPr marL="1440363" indent="0">
              <a:buNone/>
              <a:defRPr sz="394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2818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8000" y="360045"/>
            <a:ext cx="1161239" cy="1260158"/>
          </a:xfrm>
        </p:spPr>
        <p:txBody>
          <a:bodyPr anchor="b"/>
          <a:lstStyle>
            <a:lvl1pPr>
              <a:defRPr sz="126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0660" y="777598"/>
            <a:ext cx="1822728" cy="3837980"/>
          </a:xfrm>
        </p:spPr>
        <p:txBody>
          <a:bodyPr anchor="t"/>
          <a:lstStyle>
            <a:lvl1pPr marL="0" indent="0">
              <a:buNone/>
              <a:defRPr sz="1260"/>
            </a:lvl1pPr>
            <a:lvl2pPr marL="180045" indent="0">
              <a:buNone/>
              <a:defRPr sz="1103"/>
            </a:lvl2pPr>
            <a:lvl3pPr marL="360091" indent="0">
              <a:buNone/>
              <a:defRPr sz="945"/>
            </a:lvl3pPr>
            <a:lvl4pPr marL="540136" indent="0">
              <a:buNone/>
              <a:defRPr sz="788"/>
            </a:lvl4pPr>
            <a:lvl5pPr marL="720181" indent="0">
              <a:buNone/>
              <a:defRPr sz="788"/>
            </a:lvl5pPr>
            <a:lvl6pPr marL="900227" indent="0">
              <a:buNone/>
              <a:defRPr sz="788"/>
            </a:lvl6pPr>
            <a:lvl7pPr marL="1080272" indent="0">
              <a:buNone/>
              <a:defRPr sz="788"/>
            </a:lvl7pPr>
            <a:lvl8pPr marL="1260318" indent="0">
              <a:buNone/>
              <a:defRPr sz="788"/>
            </a:lvl8pPr>
            <a:lvl9pPr marL="1440363" indent="0">
              <a:buNone/>
              <a:defRPr sz="788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8000" y="1620202"/>
            <a:ext cx="1161239" cy="3001626"/>
          </a:xfrm>
        </p:spPr>
        <p:txBody>
          <a:bodyPr/>
          <a:lstStyle>
            <a:lvl1pPr marL="0" indent="0">
              <a:buNone/>
              <a:defRPr sz="630"/>
            </a:lvl1pPr>
            <a:lvl2pPr marL="180045" indent="0">
              <a:buNone/>
              <a:defRPr sz="551"/>
            </a:lvl2pPr>
            <a:lvl3pPr marL="360091" indent="0">
              <a:buNone/>
              <a:defRPr sz="473"/>
            </a:lvl3pPr>
            <a:lvl4pPr marL="540136" indent="0">
              <a:buNone/>
              <a:defRPr sz="394"/>
            </a:lvl4pPr>
            <a:lvl5pPr marL="720181" indent="0">
              <a:buNone/>
              <a:defRPr sz="394"/>
            </a:lvl5pPr>
            <a:lvl6pPr marL="900227" indent="0">
              <a:buNone/>
              <a:defRPr sz="394"/>
            </a:lvl6pPr>
            <a:lvl7pPr marL="1080272" indent="0">
              <a:buNone/>
              <a:defRPr sz="394"/>
            </a:lvl7pPr>
            <a:lvl8pPr marL="1260318" indent="0">
              <a:buNone/>
              <a:defRPr sz="394"/>
            </a:lvl8pPr>
            <a:lvl9pPr marL="1440363" indent="0">
              <a:buNone/>
              <a:defRPr sz="394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8167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531" y="287537"/>
            <a:ext cx="3105388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531" y="1437680"/>
            <a:ext cx="3105388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531" y="5005627"/>
            <a:ext cx="810101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E8727-57A1-4800-96FB-C222A397EF2C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2649" y="5005627"/>
            <a:ext cx="1215152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2818" y="5005627"/>
            <a:ext cx="810101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6CF018-CBD3-4CE9-B295-99E69B76FF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0445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360091" rtl="0" eaLnBrk="1" latinLnBrk="0" hangingPunct="1">
        <a:lnSpc>
          <a:spcPct val="90000"/>
        </a:lnSpc>
        <a:spcBef>
          <a:spcPct val="0"/>
        </a:spcBef>
        <a:buNone/>
        <a:defRPr sz="17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0023" indent="-90023" algn="l" defTabSz="360091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103" kern="1200">
          <a:solidFill>
            <a:schemeClr val="tx1"/>
          </a:solidFill>
          <a:latin typeface="+mn-lt"/>
          <a:ea typeface="+mn-ea"/>
          <a:cs typeface="+mn-cs"/>
        </a:defRPr>
      </a:lvl1pPr>
      <a:lvl2pPr marL="270068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2pPr>
      <a:lvl3pPr marL="450113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88" kern="1200">
          <a:solidFill>
            <a:schemeClr val="tx1"/>
          </a:solidFill>
          <a:latin typeface="+mn-lt"/>
          <a:ea typeface="+mn-ea"/>
          <a:cs typeface="+mn-cs"/>
        </a:defRPr>
      </a:lvl3pPr>
      <a:lvl4pPr marL="630159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4pPr>
      <a:lvl5pPr marL="810204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5pPr>
      <a:lvl6pPr marL="990249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6pPr>
      <a:lvl7pPr marL="1170295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7pPr>
      <a:lvl8pPr marL="1350340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8pPr>
      <a:lvl9pPr marL="1530386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1pPr>
      <a:lvl2pPr marL="180045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2pPr>
      <a:lvl3pPr marL="360091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3pPr>
      <a:lvl4pPr marL="540136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4pPr>
      <a:lvl5pPr marL="720181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5pPr>
      <a:lvl6pPr marL="900227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6pPr>
      <a:lvl7pPr marL="1080272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7pPr>
      <a:lvl8pPr marL="1260318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8pPr>
      <a:lvl9pPr marL="1440363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ieren 7"/>
          <p:cNvGrpSpPr/>
          <p:nvPr/>
        </p:nvGrpSpPr>
        <p:grpSpPr>
          <a:xfrm>
            <a:off x="1187851" y="953190"/>
            <a:ext cx="1207293" cy="2228850"/>
            <a:chOff x="571571" y="428534"/>
            <a:chExt cx="1207293" cy="2228850"/>
          </a:xfrm>
        </p:grpSpPr>
        <p:pic>
          <p:nvPicPr>
            <p:cNvPr id="71" name="Grafik 7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49" t="4937" r="35899" b="4597"/>
            <a:stretch/>
          </p:blipFill>
          <p:spPr>
            <a:xfrm>
              <a:off x="571571" y="428534"/>
              <a:ext cx="1207293" cy="2228850"/>
            </a:xfrm>
            <a:prstGeom prst="roundRect">
              <a:avLst/>
            </a:prstGeom>
          </p:spPr>
        </p:pic>
        <p:pic>
          <p:nvPicPr>
            <p:cNvPr id="77" name="Grafik 7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6" t="33151" r="1734" b="39168"/>
            <a:stretch/>
          </p:blipFill>
          <p:spPr>
            <a:xfrm>
              <a:off x="694368" y="1361307"/>
              <a:ext cx="963870" cy="622560"/>
            </a:xfrm>
            <a:prstGeom prst="rect">
              <a:avLst/>
            </a:prstGeom>
          </p:spPr>
        </p:pic>
        <p:sp>
          <p:nvSpPr>
            <p:cNvPr id="74" name="Textfeld 73"/>
            <p:cNvSpPr txBox="1"/>
            <p:nvPr/>
          </p:nvSpPr>
          <p:spPr>
            <a:xfrm>
              <a:off x="816557" y="804930"/>
              <a:ext cx="841681" cy="46166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600" dirty="0">
                  <a:solidFill>
                    <a:schemeClr val="tx2">
                      <a:lumMod val="50000"/>
                    </a:schemeClr>
                  </a:solidFill>
                </a:rPr>
                <a:t>Over the last two weeks, how often have you been bothered by any of the following problems?</a:t>
              </a:r>
            </a:p>
            <a:p>
              <a:endParaRPr lang="en-US" sz="600" dirty="0">
                <a:solidFill>
                  <a:schemeClr val="tx2">
                    <a:lumMod val="50000"/>
                  </a:schemeClr>
                </a:solidFill>
              </a:endParaRPr>
            </a:p>
          </p:txBody>
        </p:sp>
        <p:pic>
          <p:nvPicPr>
            <p:cNvPr id="75" name="Grafik 74"/>
            <p:cNvPicPr>
              <a:picLocks noChangeAspect="1"/>
            </p:cNvPicPr>
            <p:nvPr/>
          </p:nvPicPr>
          <p:blipFill rotWithShape="1">
            <a:blip r:embed="rId4"/>
            <a:srcRect l="6555" r="71209" b="92749"/>
            <a:stretch/>
          </p:blipFill>
          <p:spPr>
            <a:xfrm>
              <a:off x="626807" y="596850"/>
              <a:ext cx="739141" cy="163725"/>
            </a:xfrm>
            <a:prstGeom prst="rect">
              <a:avLst/>
            </a:prstGeom>
          </p:spPr>
        </p:pic>
        <p:sp>
          <p:nvSpPr>
            <p:cNvPr id="3" name="Rechteck 2"/>
            <p:cNvSpPr/>
            <p:nvPr/>
          </p:nvSpPr>
          <p:spPr>
            <a:xfrm>
              <a:off x="626807" y="1203718"/>
              <a:ext cx="1125629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600" b="1" noProof="1">
                  <a:solidFill>
                    <a:srgbClr val="4FC3B0"/>
                  </a:solidFill>
                  <a:ea typeface="Inter" panose="020B0502030000000004" pitchFamily="34" charset="0"/>
                  <a:cs typeface="Times New Roman" panose="02020603050405020304" pitchFamily="18" charset="0"/>
                </a:rPr>
                <a:t>Little interest in doing things </a:t>
              </a:r>
              <a:endParaRPr lang="en-US" sz="1400" dirty="0"/>
            </a:p>
          </p:txBody>
        </p:sp>
        <p:sp>
          <p:nvSpPr>
            <p:cNvPr id="4" name="Rechteck 3"/>
            <p:cNvSpPr/>
            <p:nvPr/>
          </p:nvSpPr>
          <p:spPr>
            <a:xfrm>
              <a:off x="715510" y="826770"/>
              <a:ext cx="45719" cy="321163"/>
            </a:xfrm>
            <a:prstGeom prst="rect">
              <a:avLst/>
            </a:prstGeom>
            <a:solidFill>
              <a:srgbClr val="52358E"/>
            </a:solidFill>
            <a:ln>
              <a:solidFill>
                <a:srgbClr val="52358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82" name="Grafik 81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6" t="33151" r="1734" b="62539"/>
            <a:stretch/>
          </p:blipFill>
          <p:spPr>
            <a:xfrm>
              <a:off x="693282" y="2286314"/>
              <a:ext cx="963870" cy="96928"/>
            </a:xfrm>
            <a:prstGeom prst="rect">
              <a:avLst/>
            </a:prstGeom>
          </p:spPr>
        </p:pic>
        <p:pic>
          <p:nvPicPr>
            <p:cNvPr id="76" name="Grafik 7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4" t="83411" r="4321" b="9646"/>
            <a:stretch/>
          </p:blipFill>
          <p:spPr>
            <a:xfrm>
              <a:off x="652448" y="2360929"/>
              <a:ext cx="1055381" cy="173622"/>
            </a:xfrm>
            <a:prstGeom prst="rect">
              <a:avLst/>
            </a:prstGeom>
          </p:spPr>
        </p:pic>
        <p:sp>
          <p:nvSpPr>
            <p:cNvPr id="6" name="Rechteck 5"/>
            <p:cNvSpPr/>
            <p:nvPr/>
          </p:nvSpPr>
          <p:spPr>
            <a:xfrm>
              <a:off x="728432" y="1411504"/>
              <a:ext cx="535889" cy="83745"/>
            </a:xfrm>
            <a:prstGeom prst="rect">
              <a:avLst/>
            </a:prstGeom>
            <a:solidFill>
              <a:srgbClr val="EEFBF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500" dirty="0">
                  <a:solidFill>
                    <a:srgbClr val="020044"/>
                  </a:solidFill>
                </a:rPr>
                <a:t>Not at all</a:t>
              </a:r>
            </a:p>
          </p:txBody>
        </p:sp>
        <p:sp>
          <p:nvSpPr>
            <p:cNvPr id="78" name="Rechteck 77"/>
            <p:cNvSpPr/>
            <p:nvPr/>
          </p:nvSpPr>
          <p:spPr>
            <a:xfrm>
              <a:off x="728432" y="1555190"/>
              <a:ext cx="535889" cy="83745"/>
            </a:xfrm>
            <a:prstGeom prst="rect">
              <a:avLst/>
            </a:prstGeom>
            <a:solidFill>
              <a:srgbClr val="EEFBF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500" dirty="0">
                  <a:solidFill>
                    <a:srgbClr val="020044"/>
                  </a:solidFill>
                </a:rPr>
                <a:t>Several days</a:t>
              </a:r>
            </a:p>
          </p:txBody>
        </p:sp>
        <p:sp>
          <p:nvSpPr>
            <p:cNvPr id="79" name="Rechteck 78"/>
            <p:cNvSpPr/>
            <p:nvPr/>
          </p:nvSpPr>
          <p:spPr>
            <a:xfrm>
              <a:off x="728432" y="1707891"/>
              <a:ext cx="810013" cy="75512"/>
            </a:xfrm>
            <a:prstGeom prst="rect">
              <a:avLst/>
            </a:prstGeom>
            <a:solidFill>
              <a:srgbClr val="EEFBF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500" dirty="0">
                  <a:solidFill>
                    <a:srgbClr val="020044"/>
                  </a:solidFill>
                </a:rPr>
                <a:t>More than half the days</a:t>
              </a:r>
            </a:p>
          </p:txBody>
        </p:sp>
        <p:sp>
          <p:nvSpPr>
            <p:cNvPr id="80" name="Rechteck 79"/>
            <p:cNvSpPr/>
            <p:nvPr/>
          </p:nvSpPr>
          <p:spPr>
            <a:xfrm>
              <a:off x="728432" y="1848597"/>
              <a:ext cx="740675" cy="92395"/>
            </a:xfrm>
            <a:prstGeom prst="rect">
              <a:avLst/>
            </a:prstGeom>
            <a:solidFill>
              <a:srgbClr val="EEFBF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500" dirty="0">
                  <a:solidFill>
                    <a:srgbClr val="020044"/>
                  </a:solidFill>
                </a:rPr>
                <a:t>Nearly every day</a:t>
              </a:r>
            </a:p>
          </p:txBody>
        </p:sp>
        <p:sp>
          <p:nvSpPr>
            <p:cNvPr id="81" name="Rechteck 80"/>
            <p:cNvSpPr/>
            <p:nvPr/>
          </p:nvSpPr>
          <p:spPr>
            <a:xfrm>
              <a:off x="626806" y="2026214"/>
              <a:ext cx="103143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600" b="1" noProof="1">
                  <a:solidFill>
                    <a:srgbClr val="4FC3B0"/>
                  </a:solidFill>
                  <a:ea typeface="Inter" panose="020B0502030000000004" pitchFamily="34" charset="0"/>
                  <a:cs typeface="Times New Roman" panose="02020603050405020304" pitchFamily="18" charset="0"/>
                </a:rPr>
                <a:t>Feeling down, depressed, or hopeless</a:t>
              </a:r>
              <a:endParaRPr lang="en-US" sz="1400" dirty="0"/>
            </a:p>
          </p:txBody>
        </p:sp>
        <p:sp>
          <p:nvSpPr>
            <p:cNvPr id="7" name="Rechteck 6"/>
            <p:cNvSpPr/>
            <p:nvPr/>
          </p:nvSpPr>
          <p:spPr>
            <a:xfrm>
              <a:off x="904352" y="2383242"/>
              <a:ext cx="564755" cy="7495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Rechteck 82"/>
            <p:cNvSpPr/>
            <p:nvPr/>
          </p:nvSpPr>
          <p:spPr>
            <a:xfrm>
              <a:off x="891592" y="2343104"/>
              <a:ext cx="543739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500" noProof="1">
                  <a:solidFill>
                    <a:srgbClr val="4FC3B0"/>
                  </a:solidFill>
                  <a:ea typeface="Inter" panose="020B0502030000000004" pitchFamily="34" charset="0"/>
                  <a:cs typeface="Times New Roman" panose="02020603050405020304" pitchFamily="18" charset="0"/>
                </a:rPr>
                <a:t>0/9 answered</a:t>
              </a:r>
              <a:endParaRPr lang="en-US" sz="1200" dirty="0"/>
            </a:p>
          </p:txBody>
        </p:sp>
      </p:grpSp>
      <p:sp>
        <p:nvSpPr>
          <p:cNvPr id="117" name="Textfeld 116"/>
          <p:cNvSpPr txBox="1"/>
          <p:nvPr/>
        </p:nvSpPr>
        <p:spPr>
          <a:xfrm>
            <a:off x="283028" y="245037"/>
            <a:ext cx="2850395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800" b="1" dirty="0" smtClean="0">
                <a:latin typeface="+mj-lt"/>
                <a:cs typeface="Times New Roman" panose="02020603050405020304" pitchFamily="18" charset="0"/>
              </a:rPr>
              <a:t>Multimedia </a:t>
            </a:r>
            <a:r>
              <a:rPr lang="en-GB" sz="800" b="1" dirty="0" smtClean="0">
                <a:latin typeface="+mj-lt"/>
                <a:cs typeface="Times New Roman" panose="02020603050405020304" pitchFamily="18" charset="0"/>
              </a:rPr>
              <a:t>Appendix</a:t>
            </a:r>
            <a:r>
              <a:rPr lang="en-GB" sz="800" i="1" dirty="0" smtClean="0">
                <a:latin typeface="+mj-lt"/>
                <a:cs typeface="Times New Roman" panose="02020603050405020304" pitchFamily="18" charset="0"/>
              </a:rPr>
              <a:t>: </a:t>
            </a:r>
            <a:r>
              <a:rPr lang="en-US" sz="800" dirty="0">
                <a:latin typeface="+mj-lt"/>
                <a:cs typeface="Times New Roman" panose="02020603050405020304" pitchFamily="18" charset="0"/>
              </a:rPr>
              <a:t>Illustration of the </a:t>
            </a:r>
            <a:r>
              <a:rPr lang="en-US" sz="800" dirty="0" err="1">
                <a:latin typeface="+mj-lt"/>
                <a:cs typeface="Times New Roman" panose="02020603050405020304" pitchFamily="18" charset="0"/>
              </a:rPr>
              <a:t>digitised</a:t>
            </a:r>
            <a:r>
              <a:rPr lang="en-US" sz="800" dirty="0">
                <a:latin typeface="+mj-lt"/>
                <a:cs typeface="Times New Roman" panose="02020603050405020304" pitchFamily="18" charset="0"/>
              </a:rPr>
              <a:t> PHQ-9 as displayed to study participants (mobile version</a:t>
            </a:r>
            <a:r>
              <a:rPr lang="en-US" sz="800" dirty="0" smtClean="0">
                <a:latin typeface="+mj-lt"/>
                <a:cs typeface="Times New Roman" panose="02020603050405020304" pitchFamily="18" charset="0"/>
              </a:rPr>
              <a:t>). </a:t>
            </a:r>
            <a:endParaRPr lang="en-GB" sz="800" dirty="0">
              <a:latin typeface="+mj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97336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3</Words>
  <Application>Microsoft Office PowerPoint</Application>
  <PresentationFormat>Benutzerdefiniert</PresentationFormat>
  <Paragraphs>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Inter</vt:lpstr>
      <vt:lpstr>Times New Roman</vt:lpstr>
      <vt:lpstr>Office</vt:lpstr>
      <vt:lpstr>PowerPoint-Präsentation</vt:lpstr>
    </vt:vector>
  </TitlesOfParts>
  <Company>UK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adke, Marie Phoebe</dc:creator>
  <cp:lastModifiedBy>Sikorski, Franziska</cp:lastModifiedBy>
  <cp:revision>48</cp:revision>
  <dcterms:created xsi:type="dcterms:W3CDTF">2023-11-23T09:09:03Z</dcterms:created>
  <dcterms:modified xsi:type="dcterms:W3CDTF">2024-04-12T18:23:45Z</dcterms:modified>
</cp:coreProperties>
</file>